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heme/theme2.xml" ContentType="application/vnd.openxmlformats-officedocument.theme+xml"/>
  <Override PartName="/ppt/tags/tag6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662" y="102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899153" y="914462"/>
            <a:ext cx="7349831" cy="2570573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899153" y="3560640"/>
            <a:ext cx="7349831" cy="1472499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9435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456327" y="774052"/>
            <a:ext cx="8230083" cy="548317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899153" y="2484168"/>
            <a:ext cx="7349831" cy="1018869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899153" y="3560640"/>
            <a:ext cx="7349831" cy="471632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456327" y="1490501"/>
            <a:ext cx="8227383" cy="4759521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493188" y="3848660"/>
            <a:ext cx="5826942" cy="766852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493188" y="4615511"/>
            <a:ext cx="5826942" cy="867659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94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456327" y="1501301"/>
            <a:ext cx="3882828" cy="474872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4808982" y="1501301"/>
            <a:ext cx="3882828" cy="474872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456327" y="1429296"/>
            <a:ext cx="4007035" cy="381626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9435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456327" y="1854125"/>
            <a:ext cx="4007035" cy="4395897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4677087" y="1421825"/>
            <a:ext cx="4007035" cy="381626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9435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4677087" y="1854125"/>
            <a:ext cx="4007035" cy="4395897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456274" y="1555220"/>
            <a:ext cx="3925006" cy="4608506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4763079" y="1555305"/>
            <a:ext cx="3920630" cy="4608311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2/9/20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7676550" y="914462"/>
            <a:ext cx="783046" cy="5029539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685840" y="914462"/>
            <a:ext cx="6877303" cy="5029539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456327" y="608441"/>
            <a:ext cx="8227383" cy="705648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456327" y="1490501"/>
            <a:ext cx="8227383" cy="4759521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459027" y="6314826"/>
            <a:ext cx="2025119" cy="316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3087181" y="6314826"/>
            <a:ext cx="2970174" cy="316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6658591" y="6314826"/>
            <a:ext cx="2025119" cy="316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2435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9435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3"/>
          <a:srcRect t="9985"/>
          <a:stretch/>
        </p:blipFill>
        <p:spPr>
          <a:xfrm>
            <a:off x="521970" y="1017142"/>
            <a:ext cx="8100060" cy="5425568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00CF717-82FB-4533-9AD6-1C4318D993B7}"/>
              </a:ext>
            </a:extLst>
          </p:cNvPr>
          <p:cNvSpPr txBox="1"/>
          <p:nvPr/>
        </p:nvSpPr>
        <p:spPr>
          <a:xfrm>
            <a:off x="222906" y="252590"/>
            <a:ext cx="839912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/>
              <a:t>Additional file 4 </a:t>
            </a:r>
            <a:r>
              <a:rPr lang="en-US" altLang="zh-CN" sz="1400" dirty="0"/>
              <a:t>High correlation between the two technical replicates. The scatterplot of two technical replicates treated with 20/80/160 </a:t>
            </a:r>
            <a:r>
              <a:rPr lang="en-US" altLang="zh-CN" sz="1400" dirty="0" err="1"/>
              <a:t>Gy</a:t>
            </a:r>
            <a:r>
              <a:rPr lang="en-US" altLang="zh-CN" sz="1400" dirty="0"/>
              <a:t> heavy ion irradiation.</a:t>
            </a:r>
            <a:endParaRPr lang="zh-CN" altLang="en-US" sz="1400" dirty="0"/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Wingdings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an</dc:creator>
  <cp:lastModifiedBy>2021027@njau.edu.cn</cp:lastModifiedBy>
  <cp:revision>182</cp:revision>
  <dcterms:created xsi:type="dcterms:W3CDTF">2019-06-19T02:08:00Z</dcterms:created>
  <dcterms:modified xsi:type="dcterms:W3CDTF">2022-09-20T03:27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365</vt:lpwstr>
  </property>
  <property fmtid="{D5CDD505-2E9C-101B-9397-08002B2CF9AE}" pid="3" name="ICV">
    <vt:lpwstr>15C065FB1E98446EAA189C1A1E1155ED</vt:lpwstr>
  </property>
</Properties>
</file>